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335713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32080" y="685440"/>
            <a:ext cx="2193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 Unicode MS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8656A9-A41E-43F5-9BFC-8721F3646786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sldImg"/>
          </p:nvPr>
        </p:nvSpPr>
        <p:spPr>
          <a:xfrm>
            <a:off x="2332080" y="685800"/>
            <a:ext cx="2193840" cy="3429000"/>
          </a:xfrm>
          <a:prstGeom prst="rect">
            <a:avLst/>
          </a:prstGeom>
          <a:ln w="0">
            <a:noFill/>
          </a:ln>
        </p:spPr>
      </p:sp>
      <p:sp>
        <p:nvSpPr>
          <p:cNvPr id="12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7C422B-F379-4030-BCFA-60E53D2517BC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F3C3D3-9615-4440-BCBC-EC80C2DF9C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B64A8B-CE65-4CAA-A658-AC850C4895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770A50-92B5-42E3-B34C-596A976301C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4568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7384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752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4568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7384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5DA93-E723-4C30-A4D9-CB42448BBD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211DF8-2555-4FB3-97E6-E8191D9E28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45C6E-2F0B-4E5C-B6F3-2A1810375A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6498A-5721-413F-A5F1-C6B11CC805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142228-5AF0-41E4-87CB-2FE2E65607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7520" y="396360"/>
            <a:ext cx="57024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E54753-72FD-40FF-A9EC-D1CDD1E281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7116B2-2D33-4BAB-ADCB-3FFF8E766E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2E4DA9-AA5A-4683-B157-4940ABF751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2F8F2-4259-40B9-88D5-6F85534582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 Unicode MS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7160" y="9182160"/>
            <a:ext cx="1477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65400" y="9182160"/>
            <a:ext cx="200664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41760" y="9182160"/>
            <a:ext cx="14781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734A1C-F9F6-40A1-9A47-0E012BA034F1}" type="slidenum"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85"/>
          <p:cNvGrpSpPr/>
          <p:nvPr/>
        </p:nvGrpSpPr>
        <p:grpSpPr>
          <a:xfrm>
            <a:off x="3456000" y="3441600"/>
            <a:ext cx="2736720" cy="2375640"/>
            <a:chOff x="3456000" y="3441600"/>
            <a:chExt cx="2736720" cy="2375640"/>
          </a:xfrm>
        </p:grpSpPr>
        <p:pic>
          <p:nvPicPr>
            <p:cNvPr id="49" name="グラフ 32" descr=""/>
            <p:cNvPicPr/>
            <p:nvPr/>
          </p:nvPicPr>
          <p:blipFill>
            <a:blip r:embed="rId1"/>
            <a:stretch/>
          </p:blipFill>
          <p:spPr>
            <a:xfrm>
              <a:off x="3669480" y="3441600"/>
              <a:ext cx="2523240" cy="2161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テキスト ボックス 40"/>
            <p:cNvSpPr/>
            <p:nvPr/>
          </p:nvSpPr>
          <p:spPr>
            <a:xfrm>
              <a:off x="4664880" y="5601600"/>
              <a:ext cx="49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FAP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テキスト ボックス 41"/>
            <p:cNvSpPr/>
            <p:nvPr/>
          </p:nvSpPr>
          <p:spPr>
            <a:xfrm rot="16200000">
              <a:off x="3256200" y="4411800"/>
              <a:ext cx="61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FAP1L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2" name="グループ化 79"/>
          <p:cNvGrpSpPr/>
          <p:nvPr/>
        </p:nvGrpSpPr>
        <p:grpSpPr>
          <a:xfrm>
            <a:off x="-92160" y="6378480"/>
            <a:ext cx="3095640" cy="2340000"/>
            <a:chOff x="-92160" y="6378480"/>
            <a:chExt cx="3095640" cy="2340000"/>
          </a:xfrm>
        </p:grpSpPr>
        <p:pic>
          <p:nvPicPr>
            <p:cNvPr id="53" name="グラフ 54" descr=""/>
            <p:cNvPicPr/>
            <p:nvPr/>
          </p:nvPicPr>
          <p:blipFill>
            <a:blip r:embed="rId2"/>
            <a:stretch/>
          </p:blipFill>
          <p:spPr>
            <a:xfrm>
              <a:off x="-92160" y="6378480"/>
              <a:ext cx="3095640" cy="23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テキスト ボックス 4"/>
            <p:cNvSpPr/>
            <p:nvPr/>
          </p:nvSpPr>
          <p:spPr>
            <a:xfrm>
              <a:off x="1347120" y="6562440"/>
              <a:ext cx="692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FAP1L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直線コネクタ 40"/>
            <p:cNvSpPr/>
            <p:nvPr/>
          </p:nvSpPr>
          <p:spPr>
            <a:xfrm flipH="1">
              <a:off x="396360" y="7540920"/>
              <a:ext cx="2513520" cy="0"/>
            </a:xfrm>
            <a:prstGeom prst="line">
              <a:avLst/>
            </a:prstGeom>
            <a:ln w="1908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6" name="グループ化 589"/>
            <p:cNvGrpSpPr/>
            <p:nvPr/>
          </p:nvGrpSpPr>
          <p:grpSpPr>
            <a:xfrm>
              <a:off x="605880" y="8240760"/>
              <a:ext cx="1707480" cy="404280"/>
              <a:chOff x="605880" y="8240760"/>
              <a:chExt cx="1707480" cy="404280"/>
            </a:xfrm>
          </p:grpSpPr>
          <p:sp>
            <p:nvSpPr>
              <p:cNvPr id="57" name="正方形/長方形 44"/>
              <p:cNvSpPr/>
              <p:nvPr/>
            </p:nvSpPr>
            <p:spPr>
              <a:xfrm>
                <a:off x="1080000" y="8311680"/>
                <a:ext cx="158400" cy="7272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正方形/長方形 45"/>
              <p:cNvSpPr/>
              <p:nvPr/>
            </p:nvSpPr>
            <p:spPr>
              <a:xfrm>
                <a:off x="1450800" y="8311680"/>
                <a:ext cx="158400" cy="72720"/>
              </a:xfrm>
              <a:prstGeom prst="rect">
                <a:avLst/>
              </a:prstGeom>
              <a:solidFill>
                <a:srgbClr val="4bacc6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正方形/長方形 46"/>
              <p:cNvSpPr/>
              <p:nvPr/>
            </p:nvSpPr>
            <p:spPr>
              <a:xfrm>
                <a:off x="1888200" y="8311680"/>
                <a:ext cx="159840" cy="72720"/>
              </a:xfrm>
              <a:prstGeom prst="rect">
                <a:avLst/>
              </a:prstGeom>
              <a:solidFill>
                <a:srgbClr val="ffff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正方形/長方形 47"/>
              <p:cNvSpPr/>
              <p:nvPr/>
            </p:nvSpPr>
            <p:spPr>
              <a:xfrm>
                <a:off x="1080000" y="8500320"/>
                <a:ext cx="158400" cy="72720"/>
              </a:xfrm>
              <a:prstGeom prst="rect">
                <a:avLst/>
              </a:prstGeom>
              <a:solidFill>
                <a:srgbClr val="40404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正方形/長方形 48"/>
              <p:cNvSpPr/>
              <p:nvPr/>
            </p:nvSpPr>
            <p:spPr>
              <a:xfrm>
                <a:off x="1450800" y="8500320"/>
                <a:ext cx="158400" cy="72720"/>
              </a:xfrm>
              <a:prstGeom prst="rect">
                <a:avLst/>
              </a:prstGeom>
              <a:solidFill>
                <a:srgbClr val="ff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テキスト ボックス 49"/>
              <p:cNvSpPr/>
              <p:nvPr/>
            </p:nvSpPr>
            <p:spPr>
              <a:xfrm>
                <a:off x="1192320" y="8240760"/>
                <a:ext cx="21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テキスト ボックス 50"/>
              <p:cNvSpPr/>
              <p:nvPr/>
            </p:nvSpPr>
            <p:spPr>
              <a:xfrm>
                <a:off x="1574280" y="8240760"/>
                <a:ext cx="308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I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テキスト ボックス 51"/>
              <p:cNvSpPr/>
              <p:nvPr/>
            </p:nvSpPr>
            <p:spPr>
              <a:xfrm>
                <a:off x="2000160" y="8240760"/>
                <a:ext cx="313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I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テキスト ボックス 52"/>
              <p:cNvSpPr/>
              <p:nvPr/>
            </p:nvSpPr>
            <p:spPr>
              <a:xfrm>
                <a:off x="1189080" y="8429400"/>
                <a:ext cx="285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I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テキスト ボックス 53"/>
              <p:cNvSpPr/>
              <p:nvPr/>
            </p:nvSpPr>
            <p:spPr>
              <a:xfrm>
                <a:off x="1580760" y="8429400"/>
                <a:ext cx="276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V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テキスト ボックス 54"/>
              <p:cNvSpPr/>
              <p:nvPr/>
            </p:nvSpPr>
            <p:spPr>
              <a:xfrm>
                <a:off x="605880" y="8330400"/>
                <a:ext cx="45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tag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8" name="グループ化 78"/>
          <p:cNvGrpSpPr/>
          <p:nvPr/>
        </p:nvGrpSpPr>
        <p:grpSpPr>
          <a:xfrm>
            <a:off x="-92160" y="3440160"/>
            <a:ext cx="3095640" cy="2340000"/>
            <a:chOff x="-92160" y="3440160"/>
            <a:chExt cx="3095640" cy="2340000"/>
          </a:xfrm>
        </p:grpSpPr>
        <p:pic>
          <p:nvPicPr>
            <p:cNvPr id="69" name="グラフ 50" descr=""/>
            <p:cNvPicPr/>
            <p:nvPr/>
          </p:nvPicPr>
          <p:blipFill>
            <a:blip r:embed="rId3"/>
            <a:stretch/>
          </p:blipFill>
          <p:spPr>
            <a:xfrm>
              <a:off x="-92160" y="3440160"/>
              <a:ext cx="3095640" cy="23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テキスト ボックス 3"/>
            <p:cNvSpPr/>
            <p:nvPr/>
          </p:nvSpPr>
          <p:spPr>
            <a:xfrm>
              <a:off x="1414800" y="3612960"/>
              <a:ext cx="55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FAP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直線コネクタ 39"/>
            <p:cNvSpPr/>
            <p:nvPr/>
          </p:nvSpPr>
          <p:spPr>
            <a:xfrm flipH="1">
              <a:off x="396360" y="4610160"/>
              <a:ext cx="2513520" cy="0"/>
            </a:xfrm>
            <a:prstGeom prst="line">
              <a:avLst/>
            </a:prstGeom>
            <a:ln w="1908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2" name="グループ化 589"/>
            <p:cNvGrpSpPr/>
            <p:nvPr/>
          </p:nvGrpSpPr>
          <p:grpSpPr>
            <a:xfrm>
              <a:off x="605880" y="5331240"/>
              <a:ext cx="1707480" cy="404280"/>
              <a:chOff x="605880" y="5331240"/>
              <a:chExt cx="1707480" cy="404280"/>
            </a:xfrm>
          </p:grpSpPr>
          <p:sp>
            <p:nvSpPr>
              <p:cNvPr id="73" name="正方形/長方形 56"/>
              <p:cNvSpPr/>
              <p:nvPr/>
            </p:nvSpPr>
            <p:spPr>
              <a:xfrm>
                <a:off x="1080000" y="5401800"/>
                <a:ext cx="158400" cy="7272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正方形/長方形 57"/>
              <p:cNvSpPr/>
              <p:nvPr/>
            </p:nvSpPr>
            <p:spPr>
              <a:xfrm>
                <a:off x="1450800" y="5401800"/>
                <a:ext cx="158400" cy="72720"/>
              </a:xfrm>
              <a:prstGeom prst="rect">
                <a:avLst/>
              </a:prstGeom>
              <a:solidFill>
                <a:srgbClr val="4bacc6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正方形/長方形 58"/>
              <p:cNvSpPr/>
              <p:nvPr/>
            </p:nvSpPr>
            <p:spPr>
              <a:xfrm>
                <a:off x="1888200" y="5401800"/>
                <a:ext cx="159840" cy="72720"/>
              </a:xfrm>
              <a:prstGeom prst="rect">
                <a:avLst/>
              </a:prstGeom>
              <a:solidFill>
                <a:srgbClr val="ffff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正方形/長方形 59"/>
              <p:cNvSpPr/>
              <p:nvPr/>
            </p:nvSpPr>
            <p:spPr>
              <a:xfrm>
                <a:off x="1080000" y="5590080"/>
                <a:ext cx="158400" cy="72720"/>
              </a:xfrm>
              <a:prstGeom prst="rect">
                <a:avLst/>
              </a:prstGeom>
              <a:solidFill>
                <a:srgbClr val="40404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正方形/長方形 60"/>
              <p:cNvSpPr/>
              <p:nvPr/>
            </p:nvSpPr>
            <p:spPr>
              <a:xfrm>
                <a:off x="1450800" y="5590080"/>
                <a:ext cx="158400" cy="72720"/>
              </a:xfrm>
              <a:prstGeom prst="rect">
                <a:avLst/>
              </a:prstGeom>
              <a:solidFill>
                <a:srgbClr val="ff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テキスト ボックス 61"/>
              <p:cNvSpPr/>
              <p:nvPr/>
            </p:nvSpPr>
            <p:spPr>
              <a:xfrm>
                <a:off x="1192320" y="5331240"/>
                <a:ext cx="21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テキスト ボックス 62"/>
              <p:cNvSpPr/>
              <p:nvPr/>
            </p:nvSpPr>
            <p:spPr>
              <a:xfrm>
                <a:off x="1574280" y="5331240"/>
                <a:ext cx="308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I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テキスト ボックス 63"/>
              <p:cNvSpPr/>
              <p:nvPr/>
            </p:nvSpPr>
            <p:spPr>
              <a:xfrm>
                <a:off x="2000160" y="5331240"/>
                <a:ext cx="313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I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テキスト ボックス 64"/>
              <p:cNvSpPr/>
              <p:nvPr/>
            </p:nvSpPr>
            <p:spPr>
              <a:xfrm>
                <a:off x="1189080" y="5519880"/>
                <a:ext cx="285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I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テキスト ボックス 65"/>
              <p:cNvSpPr/>
              <p:nvPr/>
            </p:nvSpPr>
            <p:spPr>
              <a:xfrm>
                <a:off x="1580760" y="5519880"/>
                <a:ext cx="276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V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テキスト ボックス 66"/>
              <p:cNvSpPr/>
              <p:nvPr/>
            </p:nvSpPr>
            <p:spPr>
              <a:xfrm>
                <a:off x="605880" y="5420880"/>
                <a:ext cx="45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tag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84" name="テキスト ボックス 142"/>
          <p:cNvSpPr/>
          <p:nvPr/>
        </p:nvSpPr>
        <p:spPr>
          <a:xfrm>
            <a:off x="1440" y="298440"/>
            <a:ext cx="25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テキスト ボックス 142"/>
          <p:cNvSpPr/>
          <p:nvPr/>
        </p:nvSpPr>
        <p:spPr>
          <a:xfrm>
            <a:off x="3024000" y="298440"/>
            <a:ext cx="26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142"/>
          <p:cNvSpPr/>
          <p:nvPr/>
        </p:nvSpPr>
        <p:spPr>
          <a:xfrm>
            <a:off x="6840" y="3252960"/>
            <a:ext cx="24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テキスト ボックス 142"/>
          <p:cNvSpPr/>
          <p:nvPr/>
        </p:nvSpPr>
        <p:spPr>
          <a:xfrm>
            <a:off x="3024000" y="3252960"/>
            <a:ext cx="26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テキスト ボックス 141"/>
          <p:cNvSpPr/>
          <p:nvPr/>
        </p:nvSpPr>
        <p:spPr>
          <a:xfrm>
            <a:off x="-25560" y="0"/>
            <a:ext cx="176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upplementary Figure 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グループ化 77"/>
          <p:cNvGrpSpPr/>
          <p:nvPr/>
        </p:nvGrpSpPr>
        <p:grpSpPr>
          <a:xfrm>
            <a:off x="0" y="515880"/>
            <a:ext cx="3095640" cy="2340000"/>
            <a:chOff x="0" y="515880"/>
            <a:chExt cx="3095640" cy="2340000"/>
          </a:xfrm>
        </p:grpSpPr>
        <p:pic>
          <p:nvPicPr>
            <p:cNvPr id="90" name="グラフ 62" descr=""/>
            <p:cNvPicPr/>
            <p:nvPr/>
          </p:nvPicPr>
          <p:blipFill>
            <a:blip r:embed="rId4"/>
            <a:stretch/>
          </p:blipFill>
          <p:spPr>
            <a:xfrm>
              <a:off x="0" y="515880"/>
              <a:ext cx="3095640" cy="234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1" name="直線コネクタ 49"/>
            <p:cNvSpPr/>
            <p:nvPr/>
          </p:nvSpPr>
          <p:spPr>
            <a:xfrm flipH="1">
              <a:off x="483840" y="1683000"/>
              <a:ext cx="2518560" cy="0"/>
            </a:xfrm>
            <a:prstGeom prst="line">
              <a:avLst/>
            </a:prstGeom>
            <a:ln w="1908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2" name="グループ化 589"/>
            <p:cNvGrpSpPr/>
            <p:nvPr/>
          </p:nvGrpSpPr>
          <p:grpSpPr>
            <a:xfrm>
              <a:off x="694440" y="2408760"/>
              <a:ext cx="1710360" cy="404280"/>
              <a:chOff x="694440" y="2408760"/>
              <a:chExt cx="1710360" cy="404280"/>
            </a:xfrm>
          </p:grpSpPr>
          <p:sp>
            <p:nvSpPr>
              <p:cNvPr id="93" name="正方形/長方形 52"/>
              <p:cNvSpPr/>
              <p:nvPr/>
            </p:nvSpPr>
            <p:spPr>
              <a:xfrm>
                <a:off x="1169280" y="2479320"/>
                <a:ext cx="158400" cy="72720"/>
              </a:xfrm>
              <a:prstGeom prst="rect">
                <a:avLst/>
              </a:prstGeom>
              <a:solidFill>
                <a:srgbClr val="ffffff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正方形/長方形 53"/>
              <p:cNvSpPr/>
              <p:nvPr/>
            </p:nvSpPr>
            <p:spPr>
              <a:xfrm>
                <a:off x="1540800" y="2479320"/>
                <a:ext cx="158400" cy="72720"/>
              </a:xfrm>
              <a:prstGeom prst="rect">
                <a:avLst/>
              </a:prstGeom>
              <a:solidFill>
                <a:srgbClr val="4bacc6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正方形/長方形 55"/>
              <p:cNvSpPr/>
              <p:nvPr/>
            </p:nvSpPr>
            <p:spPr>
              <a:xfrm>
                <a:off x="1978920" y="2479320"/>
                <a:ext cx="160200" cy="72720"/>
              </a:xfrm>
              <a:prstGeom prst="rect">
                <a:avLst/>
              </a:prstGeom>
              <a:solidFill>
                <a:srgbClr val="ffff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正方形/長方形 61"/>
              <p:cNvSpPr/>
              <p:nvPr/>
            </p:nvSpPr>
            <p:spPr>
              <a:xfrm>
                <a:off x="1169280" y="2667600"/>
                <a:ext cx="158400" cy="72720"/>
              </a:xfrm>
              <a:prstGeom prst="rect">
                <a:avLst/>
              </a:prstGeom>
              <a:solidFill>
                <a:srgbClr val="40404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正方形/長方形 63"/>
              <p:cNvSpPr/>
              <p:nvPr/>
            </p:nvSpPr>
            <p:spPr>
              <a:xfrm>
                <a:off x="1540800" y="2667600"/>
                <a:ext cx="158400" cy="72720"/>
              </a:xfrm>
              <a:prstGeom prst="rect">
                <a:avLst/>
              </a:prstGeom>
              <a:solidFill>
                <a:srgbClr val="ff000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テキスト ボックス 49"/>
              <p:cNvSpPr/>
              <p:nvPr/>
            </p:nvSpPr>
            <p:spPr>
              <a:xfrm>
                <a:off x="1281960" y="2408760"/>
                <a:ext cx="215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テキスト ボックス 50"/>
              <p:cNvSpPr/>
              <p:nvPr/>
            </p:nvSpPr>
            <p:spPr>
              <a:xfrm>
                <a:off x="1665000" y="2408760"/>
                <a:ext cx="308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I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テキスト ボックス 51"/>
              <p:cNvSpPr/>
              <p:nvPr/>
            </p:nvSpPr>
            <p:spPr>
              <a:xfrm>
                <a:off x="2091600" y="2408760"/>
                <a:ext cx="313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I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テキスト ボックス 52"/>
              <p:cNvSpPr/>
              <p:nvPr/>
            </p:nvSpPr>
            <p:spPr>
              <a:xfrm>
                <a:off x="1279080" y="2597400"/>
                <a:ext cx="285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I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テキスト ボックス 53"/>
              <p:cNvSpPr/>
              <p:nvPr/>
            </p:nvSpPr>
            <p:spPr>
              <a:xfrm>
                <a:off x="1671480" y="2597400"/>
                <a:ext cx="276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IV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テキスト ボックス 54"/>
              <p:cNvSpPr/>
              <p:nvPr/>
            </p:nvSpPr>
            <p:spPr>
              <a:xfrm>
                <a:off x="694440" y="2498400"/>
                <a:ext cx="452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 Unicode MS"/>
                    <a:ea typeface="Arial Unicode MS"/>
                  </a:rPr>
                  <a:t>Stag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4" name="テキスト ボックス 4"/>
            <p:cNvSpPr/>
            <p:nvPr/>
          </p:nvSpPr>
          <p:spPr>
            <a:xfrm>
              <a:off x="1437480" y="734760"/>
              <a:ext cx="692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847800"/>
                  <a:tab algn="l" pos="1695600"/>
                  <a:tab algn="l" pos="2543040"/>
                  <a:tab algn="l" pos="3390840"/>
                  <a:tab algn="l" pos="4238640"/>
                  <a:tab algn="l" pos="5086440"/>
                  <a:tab algn="l" pos="5934240"/>
                  <a:tab algn="l" pos="6781680"/>
                  <a:tab algn="l" pos="7629480"/>
                  <a:tab algn="l" pos="8477280"/>
                  <a:tab algn="l" pos="9325080"/>
                  <a:tab algn="l" pos="1017288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FAP1L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5" name="テキスト ボックス 142"/>
          <p:cNvSpPr/>
          <p:nvPr/>
        </p:nvSpPr>
        <p:spPr>
          <a:xfrm>
            <a:off x="2520" y="6105600"/>
            <a:ext cx="25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テキスト ボックス 142"/>
          <p:cNvSpPr/>
          <p:nvPr/>
        </p:nvSpPr>
        <p:spPr>
          <a:xfrm>
            <a:off x="3020760" y="610560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7" name="グループ化 84"/>
          <p:cNvGrpSpPr/>
          <p:nvPr/>
        </p:nvGrpSpPr>
        <p:grpSpPr>
          <a:xfrm>
            <a:off x="3456000" y="6381720"/>
            <a:ext cx="2727360" cy="2315160"/>
            <a:chOff x="3456000" y="6381720"/>
            <a:chExt cx="2727360" cy="2315160"/>
          </a:xfrm>
        </p:grpSpPr>
        <p:pic>
          <p:nvPicPr>
            <p:cNvPr id="108" name="グラフ 36" descr=""/>
            <p:cNvPicPr/>
            <p:nvPr/>
          </p:nvPicPr>
          <p:blipFill>
            <a:blip r:embed="rId5"/>
            <a:stretch/>
          </p:blipFill>
          <p:spPr>
            <a:xfrm>
              <a:off x="3657240" y="6381720"/>
              <a:ext cx="2526120" cy="2165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9" name="テキスト ボックス 41"/>
            <p:cNvSpPr/>
            <p:nvPr/>
          </p:nvSpPr>
          <p:spPr>
            <a:xfrm rot="16200000">
              <a:off x="3256200" y="7349040"/>
              <a:ext cx="61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FAP1L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テキスト ボックス 40"/>
            <p:cNvSpPr/>
            <p:nvPr/>
          </p:nvSpPr>
          <p:spPr>
            <a:xfrm>
              <a:off x="4604760" y="8481240"/>
              <a:ext cx="61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AFAP1L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1" name="グループ化 92"/>
          <p:cNvGrpSpPr/>
          <p:nvPr/>
        </p:nvGrpSpPr>
        <p:grpSpPr>
          <a:xfrm>
            <a:off x="3384720" y="488880"/>
            <a:ext cx="2952720" cy="2332440"/>
            <a:chOff x="3384720" y="488880"/>
            <a:chExt cx="2952720" cy="2332440"/>
          </a:xfrm>
        </p:grpSpPr>
        <p:pic>
          <p:nvPicPr>
            <p:cNvPr id="112" name="グラフ 75" descr=""/>
            <p:cNvPicPr/>
            <p:nvPr/>
          </p:nvPicPr>
          <p:blipFill>
            <a:blip r:embed="rId6"/>
            <a:stretch/>
          </p:blipFill>
          <p:spPr>
            <a:xfrm>
              <a:off x="3493080" y="560520"/>
              <a:ext cx="2844360" cy="2091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3" name="テキスト ボックス 40"/>
            <p:cNvSpPr/>
            <p:nvPr/>
          </p:nvSpPr>
          <p:spPr>
            <a:xfrm>
              <a:off x="4192560" y="2605680"/>
              <a:ext cx="1297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Normalized by β-act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テキスト ボックス 41"/>
            <p:cNvSpPr/>
            <p:nvPr/>
          </p:nvSpPr>
          <p:spPr>
            <a:xfrm rot="16200000">
              <a:off x="2909880" y="1557720"/>
              <a:ext cx="1165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Normalized by B2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テキスト ボックス 40"/>
            <p:cNvSpPr/>
            <p:nvPr/>
          </p:nvSpPr>
          <p:spPr>
            <a:xfrm>
              <a:off x="4555440" y="488880"/>
              <a:ext cx="7369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Log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 Unicode MS"/>
                  <a:ea typeface="Arial Unicode MS"/>
                </a:rPr>
                <a:t>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[T/N]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テキスト ボックス 40"/>
            <p:cNvSpPr/>
            <p:nvPr/>
          </p:nvSpPr>
          <p:spPr>
            <a:xfrm>
              <a:off x="4906440" y="2166120"/>
              <a:ext cx="1244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Correlation coefficien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r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 Unicode MS"/>
                  <a:ea typeface="Arial Unicode MS"/>
                </a:rPr>
                <a:t>=0.7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7" name="テキスト ボックス 40"/>
          <p:cNvSpPr/>
          <p:nvPr/>
        </p:nvSpPr>
        <p:spPr>
          <a:xfrm>
            <a:off x="5076000" y="3513240"/>
            <a:ext cx="1244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orrelation coefficie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r</a:t>
            </a: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=0.4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テキスト ボックス 40"/>
          <p:cNvSpPr/>
          <p:nvPr/>
        </p:nvSpPr>
        <p:spPr>
          <a:xfrm>
            <a:off x="5076000" y="6488280"/>
            <a:ext cx="1244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orrelation coefficie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r</a:t>
            </a: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=0.1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10T07:50:08Z</dcterms:created>
  <dc:creator>Ryo　Takahashi</dc:creator>
  <dc:description/>
  <dc:language>en-US</dc:language>
  <cp:lastModifiedBy>戸口田 淳也</cp:lastModifiedBy>
  <dcterms:modified xsi:type="dcterms:W3CDTF">2013-09-16T07:17:26Z</dcterms:modified>
  <cp:revision>50</cp:revision>
  <dc:subject/>
  <dc:title>スライド 1</dc:title>
</cp:coreProperties>
</file>